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 varScale="1">
        <p:scale>
          <a:sx n="97" d="100"/>
          <a:sy n="97" d="100"/>
        </p:scale>
        <p:origin x="-108" y="-120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BBE76525-A72F-4B53-824C-62AD3E3795E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xmlns="" id="{E24E4EF6-D1E8-43D6-A48D-9A8993CBE98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C7D59E67-77A5-4BCE-AF71-FFB3401F8AF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25ED9A-450A-4F81-8EBA-44A79AD2DEDC}" type="datetimeFigureOut">
              <a:rPr lang="en-US" smtClean="0"/>
              <a:t>12/3/2018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556EA3A0-EB55-4FFD-A0ED-254FC24973C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12B01A25-CE6D-4B3C-97C2-A289C5193B2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0C3975-0019-4358-A7C7-C955041642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437287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D153F4F6-CA10-4000-B3D8-7488913F3F4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xmlns="" id="{E9DD643C-2FD4-43EE-B4ED-821D35499E1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70AC1F04-15DC-46E7-B40A-CD83DB77B3F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25ED9A-450A-4F81-8EBA-44A79AD2DEDC}" type="datetimeFigureOut">
              <a:rPr lang="en-US" smtClean="0"/>
              <a:t>12/3/2018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F0A38BC1-B206-491D-9260-9A7CD7C64C1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62EE54B7-079F-4037-9FB9-2139AD47011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0C3975-0019-4358-A7C7-C955041642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1366570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xmlns="" id="{D2BC7357-1FBC-48E0-B9E7-60F93F81379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xmlns="" id="{7C3C006E-1C7B-45EF-855B-CE71D8F91CF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A81FC5CF-EF44-4A99-A24A-BAF8D409801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25ED9A-450A-4F81-8EBA-44A79AD2DEDC}" type="datetimeFigureOut">
              <a:rPr lang="en-US" smtClean="0"/>
              <a:t>12/3/2018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0CB6BD58-4710-43F4-A27F-90595DC25E1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8C6D2EED-6585-4A43-898B-EF1724E004E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0C3975-0019-4358-A7C7-C955041642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8607140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A7243B74-3914-4314-8719-AB7FD999824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FF0F0AF2-64FD-457D-86C0-9CB5CE794FC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2797801F-75E4-4E84-9880-2ECF681FC64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25ED9A-450A-4F81-8EBA-44A79AD2DEDC}" type="datetimeFigureOut">
              <a:rPr lang="en-US" smtClean="0"/>
              <a:t>12/3/2018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DB4D9909-D670-4328-A63B-1DB6FF6FF7D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1B0056E1-BFE6-48AE-818F-39E031F51A8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0C3975-0019-4358-A7C7-C955041642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3514121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51577DEB-3486-4004-8706-D2B868B63A7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xmlns="" id="{B3B1B0D4-35E3-4AC8-B39D-F17A035E853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74075F28-6E75-461F-BA19-EF368CEC273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25ED9A-450A-4F81-8EBA-44A79AD2DEDC}" type="datetimeFigureOut">
              <a:rPr lang="en-US" smtClean="0"/>
              <a:t>12/3/2018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83785C43-F27E-45F7-9A86-23020425FB4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EE6BFDCC-D0DB-4ECD-A822-D3D811E47C4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0C3975-0019-4358-A7C7-C955041642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7448862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ACF87D13-E948-4512-888F-914DFFB6B69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BA89392F-E2F2-4F7C-A114-F8FB9C3926F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xmlns="" id="{385355E0-9CF5-4B65-9705-A515C738CDD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xmlns="" id="{0E44A6FB-4CA4-4675-821F-E0FDABEDCB4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25ED9A-450A-4F81-8EBA-44A79AD2DEDC}" type="datetimeFigureOut">
              <a:rPr lang="en-US" smtClean="0"/>
              <a:t>12/3/2018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xmlns="" id="{EC3F77DE-301E-455B-A031-CD5CA66DDD2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xmlns="" id="{3686E197-07B8-4637-8D44-4D385D16657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0C3975-0019-4358-A7C7-C955041642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9870559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FA44BDC3-1227-4BF8-9E06-A94E38C3A3F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xmlns="" id="{A2143701-CE64-439B-8313-4FF2B91D6B6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xmlns="" id="{366E150E-BC83-4037-93CD-1F95C532F28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xmlns="" id="{95704791-86CF-495A-BCE7-D6BA2C3CA46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xmlns="" id="{E5B9EEEC-D7DC-4F66-93DD-CF1FB6020E4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xmlns="" id="{76B6D0AD-6937-4C54-8A8F-E7CA3C12455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25ED9A-450A-4F81-8EBA-44A79AD2DEDC}" type="datetimeFigureOut">
              <a:rPr lang="en-US" smtClean="0"/>
              <a:t>12/3/2018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xmlns="" id="{40830745-1701-4903-8804-8BFF1E9F06F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xmlns="" id="{71CBA3FA-165C-4835-800D-2936C53490E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0C3975-0019-4358-A7C7-C955041642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5649094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10A85E81-453A-4755-8F95-F1479CF62C8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xmlns="" id="{3A16C591-C4FF-461C-91DB-E8CC7AE65BE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25ED9A-450A-4F81-8EBA-44A79AD2DEDC}" type="datetimeFigureOut">
              <a:rPr lang="en-US" smtClean="0"/>
              <a:t>12/3/2018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xmlns="" id="{ABBAFD88-F79C-415C-BC5A-0033499A297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xmlns="" id="{8B1AC639-73E6-47B8-977D-6B669180066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0C3975-0019-4358-A7C7-C955041642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8369726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xmlns="" id="{24CFA8E4-E9A7-4920-B5CE-4810EE171CB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25ED9A-450A-4F81-8EBA-44A79AD2DEDC}" type="datetimeFigureOut">
              <a:rPr lang="en-US" smtClean="0"/>
              <a:t>12/3/2018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xmlns="" id="{843F492F-6DF5-470D-993D-B5974362722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xmlns="" id="{749094F0-11D6-49C6-98A9-F26CDB8CE8E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0C3975-0019-4358-A7C7-C955041642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6210520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284A9D33-43F5-406D-BE9E-AD5278ED02E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842E7F09-BEE0-4BB8-86AF-006E55E6FF1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xmlns="" id="{638E71CB-7B82-4BB7-9BDF-1C325F4D42F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xmlns="" id="{399746F5-719C-4678-9679-92FC075862D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25ED9A-450A-4F81-8EBA-44A79AD2DEDC}" type="datetimeFigureOut">
              <a:rPr lang="en-US" smtClean="0"/>
              <a:t>12/3/2018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xmlns="" id="{94ACE075-AF23-4449-9FF8-919BC6188E9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xmlns="" id="{452A40F3-054A-48B9-815D-1A71DFB339A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0C3975-0019-4358-A7C7-C955041642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1463458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0AF932F1-EE11-440F-B37F-B9D824C2789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xmlns="" id="{85F8C94E-648E-4328-AA1C-441D7F66870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xmlns="" id="{60D21051-F4F9-4D8B-906D-FCB71A16776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xmlns="" id="{1617B443-E84E-4DEF-8D0A-A2FE7A6CB31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25ED9A-450A-4F81-8EBA-44A79AD2DEDC}" type="datetimeFigureOut">
              <a:rPr lang="en-US" smtClean="0"/>
              <a:t>12/3/2018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xmlns="" id="{E6845EC5-E4EC-4C24-ADFD-69641AADE11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xmlns="" id="{299C5AEE-4D34-453C-A49E-BCC74AF5EB6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0C3975-0019-4358-A7C7-C955041642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065652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xmlns="" id="{9D110A6B-FF7A-46C7-A916-D7D713F7BEF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xmlns="" id="{47A380A5-F2D9-4452-9213-C7CB31CE0D4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3CD6B65E-8280-488B-AEA4-91D0EFB2568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B25ED9A-450A-4F81-8EBA-44A79AD2DEDC}" type="datetimeFigureOut">
              <a:rPr lang="en-US" smtClean="0"/>
              <a:t>12/3/2018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ED5A34BB-688B-4825-8760-D8C592A3FC0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FFFBCA4C-4BD6-4430-9790-D6151C9EAA0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50C3975-0019-4358-A7C7-C955041642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9742116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xmlns="" id="{E9B04A72-2AC8-45EE-9E7D-6F69DA95834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61473" y="1677270"/>
            <a:ext cx="6869054" cy="4931629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xmlns="" id="{0A3A3592-1D73-46A4-9C85-B4BCA090211D}"/>
              </a:ext>
            </a:extLst>
          </p:cNvPr>
          <p:cNvSpPr txBox="1"/>
          <p:nvPr/>
        </p:nvSpPr>
        <p:spPr>
          <a:xfrm>
            <a:off x="798379" y="576776"/>
            <a:ext cx="1065400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/>
              <a:t>Supplemental Figure </a:t>
            </a:r>
            <a:r>
              <a:rPr lang="en-US" sz="2000" b="1" dirty="0" smtClean="0"/>
              <a:t>S3 </a:t>
            </a:r>
            <a:r>
              <a:rPr lang="en-US" sz="2000" b="1" dirty="0"/>
              <a:t>: Principal component analysis of lesional forearm samples based on </a:t>
            </a:r>
            <a:r>
              <a:rPr lang="en-US" sz="2000" b="1" dirty="0" err="1"/>
              <a:t>mRSS</a:t>
            </a:r>
            <a:endParaRPr lang="en-US" sz="2000" b="1" dirty="0"/>
          </a:p>
        </p:txBody>
      </p:sp>
    </p:spTree>
    <p:extLst>
      <p:ext uri="{BB962C8B-B14F-4D97-AF65-F5344CB8AC3E}">
        <p14:creationId xmlns:p14="http://schemas.microsoft.com/office/powerpoint/2010/main" val="355709621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14</Words>
  <Application>Microsoft Office PowerPoint</Application>
  <PresentationFormat>Custom</PresentationFormat>
  <Paragraphs>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XXX</dc:creator>
  <cp:lastModifiedBy>Jennifer Franks</cp:lastModifiedBy>
  <cp:revision>2</cp:revision>
  <dcterms:created xsi:type="dcterms:W3CDTF">2018-11-20T03:42:49Z</dcterms:created>
  <dcterms:modified xsi:type="dcterms:W3CDTF">2018-12-03T21:09:37Z</dcterms:modified>
</cp:coreProperties>
</file>